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0080625" cy="7559675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560000" cy="10692000"/>
          </a:xfrm>
          <a:prstGeom prst="rect">
            <a:avLst/>
          </a:prstGeom>
          <a:solidFill>
            <a:srgbClr val="ffffff"/>
          </a:solidFill>
          <a:ln w="936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1"/>
          <p:cNvSpPr>
            <a:spLocks noGrp="1"/>
          </p:cNvSpPr>
          <p:nvPr>
            <p:ph type="sldImg"/>
          </p:nvPr>
        </p:nvSpPr>
        <p:spPr>
          <a:xfrm>
            <a:off x="1106640" y="812520"/>
            <a:ext cx="5340240" cy="4003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755640" y="5078520"/>
            <a:ext cx="6043680" cy="480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0" y="0"/>
            <a:ext cx="32781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280040" y="0"/>
            <a:ext cx="32781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0" y="10156680"/>
            <a:ext cx="32781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3"/>
          <p:cNvSpPr>
            <a:spLocks noGrp="1"/>
          </p:cNvSpPr>
          <p:nvPr>
            <p:ph type="sldNum" idx="2"/>
          </p:nvPr>
        </p:nvSpPr>
        <p:spPr>
          <a:xfrm>
            <a:off x="4279680" y="10156320"/>
            <a:ext cx="3274920" cy="530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  <a:ea typeface="DejaVu Sans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9144000"/>
                <a:tab algn="l" pos="9601200"/>
                <a:tab algn="l" pos="10058400"/>
                <a:tab algn="l" pos="10515600"/>
              </a:tabLst>
            </a:pPr>
            <a:fld id="{21390EC1-29ED-4120-8223-AE7CBE5E1B29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DejaVu San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sldImg"/>
          </p:nvPr>
        </p:nvSpPr>
        <p:spPr>
          <a:xfrm>
            <a:off x="1106640" y="812880"/>
            <a:ext cx="5343480" cy="4006800"/>
          </a:xfrm>
          <a:prstGeom prst="rect">
            <a:avLst/>
          </a:prstGeom>
          <a:ln w="0">
            <a:noFill/>
          </a:ln>
        </p:spPr>
      </p:sp>
      <p:sp>
        <p:nvSpPr>
          <p:cNvPr id="53" name=""/>
          <p:cNvSpPr/>
          <p:nvPr/>
        </p:nvSpPr>
        <p:spPr>
          <a:xfrm>
            <a:off x="755640" y="5078520"/>
            <a:ext cx="6046920" cy="480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BC0282A-0B85-43D2-82B9-79005B44CEB4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 anchorCtr="1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88646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03280" y="4055760"/>
            <a:ext cx="88646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4320E4D-0772-4881-80E6-9DB7CDA4C56B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 anchorCtr="1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32576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45760" y="1767960"/>
            <a:ext cx="432576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03280" y="4055760"/>
            <a:ext cx="432576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45760" y="4055760"/>
            <a:ext cx="432576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FAE6313-1754-4C23-BAC1-126E31C6C64B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 anchorCtr="1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285408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0280" y="1767960"/>
            <a:ext cx="285408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497640" y="1767960"/>
            <a:ext cx="285408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03280" y="4055760"/>
            <a:ext cx="285408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0280" y="4055760"/>
            <a:ext cx="285408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497640" y="4055760"/>
            <a:ext cx="285408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2771F93-8443-4C8D-A52B-8801EE184B52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 anchorCtr="1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3280" y="1767960"/>
            <a:ext cx="8864640" cy="4380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01EF6DD-F61C-4293-BDAF-C53BF2390D03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 anchorCtr="1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8864640" cy="438012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58C2ED6-FB31-4CFB-BEBF-01C7D6F46086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 anchorCtr="1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325760" cy="438012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45760" y="1767960"/>
            <a:ext cx="4325760" cy="438012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51F7BC7-73CB-48CA-94DC-97FABEA3CC32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 anchorCtr="1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1FDBC3D-5DF4-4560-89BC-2978AF54047E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3280" y="301680"/>
            <a:ext cx="9066240" cy="582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E6B6FC5-79B9-4F60-8E6A-D765C83A32D6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 anchorCtr="1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32576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45760" y="1767960"/>
            <a:ext cx="4325760" cy="438012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03280" y="4055760"/>
            <a:ext cx="432576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5D1684C-281F-44FC-95E2-05E748183DE1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 anchorCtr="1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325760" cy="438012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45760" y="1767960"/>
            <a:ext cx="432576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45760" y="4055760"/>
            <a:ext cx="432576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29DFE24-95A6-4918-8A86-F770D8695EFC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 anchorCtr="1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32576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45760" y="1767960"/>
            <a:ext cx="432576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03280" y="4055760"/>
            <a:ext cx="88646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B45DE7A-06BC-4298-9315-EE73B8CBFC1A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 anchorCtr="1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3280" y="1767960"/>
            <a:ext cx="8864640" cy="438012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503280" y="6886440"/>
            <a:ext cx="2346120" cy="51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3448080" y="6886440"/>
            <a:ext cx="3193920" cy="51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>
          <a:xfrm>
            <a:off x="7225920" y="6886440"/>
            <a:ext cx="2343240" cy="516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9144000"/>
                <a:tab algn="l" pos="9601200"/>
                <a:tab algn="l" pos="10058400"/>
                <a:tab algn="l" pos="10515600"/>
              </a:tabLst>
            </a:pPr>
            <a:fld id="{5A67931C-DEEC-4105-BA6A-7D62EBB3A0B9}" type="slidenum">
              <a:rPr b="0" lang="en-US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1368360" y="1692360"/>
            <a:ext cx="6696000" cy="517824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431640" y="287280"/>
            <a:ext cx="8712360" cy="57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Additional file 4 :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umulative contig size for the short- (red), long- (black) and meta- (green) assemblies.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axis: Number of contigs (%).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axis: contig sizes on a log</a:t>
            </a:r>
            <a:r>
              <a:rPr b="0" lang="en-US" sz="1400" spc="-1" strike="noStrike" baseline="-33000">
                <a:solidFill>
                  <a:srgbClr val="000000"/>
                </a:solidFill>
                <a:latin typeface="Times New Roman"/>
                <a:ea typeface="Times New Roman"/>
              </a:rPr>
              <a:t>10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cale.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01T10:25:56Z</dcterms:created>
  <dc:creator>isabelle</dc:creator>
  <dc:description/>
  <dc:language>en-US</dc:language>
  <cp:lastModifiedBy>Christophe</cp:lastModifiedBy>
  <dcterms:modified xsi:type="dcterms:W3CDTF">2014-02-20T09:46:29Z</dcterms:modified>
  <cp:revision>21</cp:revision>
  <dc:subject/>
  <dc:title>Diapositive 1</dc:title>
</cp:coreProperties>
</file>